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A6BBA-300B-430D-B19E-93C9656CD9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CECED-1659-4DD5-BF31-9225BF902A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12368-693F-42FF-9FC6-CA5D6A3043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7B1151-6FF8-4A1E-8D7E-048D0899A7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9587EC-6D0D-4850-8F97-C99E927B6D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A7AB9-6B48-4DAC-9B3A-10E707FE1C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6C44C-135D-4FAA-886D-8005FA95A8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649BA-969E-4EA2-B7DA-14D910826B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F68CB-6338-45C5-8FAF-5DCB3D1CDE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3D111-E40B-407B-941B-D19C712BF8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31251-460F-4268-8D6F-1F83E3F310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E108F-AD1B-41D3-BFA9-D1160BF37E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EF02E9-7B49-4962-9CF0-52B024272B9E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1A3874-BA69-4039-9C85-19A7871E1F2A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1"/>
          <p:cNvSpPr/>
          <p:nvPr/>
        </p:nvSpPr>
        <p:spPr>
          <a:xfrm>
            <a:off x="1249200" y="2455920"/>
            <a:ext cx="648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3"/>
          <p:cNvSpPr/>
          <p:nvPr/>
        </p:nvSpPr>
        <p:spPr>
          <a:xfrm>
            <a:off x="1249200" y="4927680"/>
            <a:ext cx="648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4"/>
          <p:cNvSpPr/>
          <p:nvPr/>
        </p:nvSpPr>
        <p:spPr>
          <a:xfrm>
            <a:off x="1249200" y="1998720"/>
            <a:ext cx="648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65"/>
          <p:cNvSpPr/>
          <p:nvPr/>
        </p:nvSpPr>
        <p:spPr>
          <a:xfrm>
            <a:off x="2371680" y="1558800"/>
            <a:ext cx="42354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1  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 Three-fragment primer desig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57"/>
          <p:cNvSpPr/>
          <p:nvPr/>
        </p:nvSpPr>
        <p:spPr>
          <a:xfrm>
            <a:off x="1339920" y="273672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LR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0"/>
          <p:cNvSpPr/>
          <p:nvPr/>
        </p:nvSpPr>
        <p:spPr>
          <a:xfrm>
            <a:off x="2770200" y="2341440"/>
            <a:ext cx="719280" cy="70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                          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F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61"/>
          <p:cNvSpPr/>
          <p:nvPr/>
        </p:nvSpPr>
        <p:spPr>
          <a:xfrm>
            <a:off x="1339920" y="436248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LR3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62"/>
          <p:cNvSpPr/>
          <p:nvPr/>
        </p:nvSpPr>
        <p:spPr>
          <a:xfrm>
            <a:off x="3905280" y="2532960"/>
            <a:ext cx="2327400" cy="30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04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'-agcagcatttgcactccgatc-3 '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69"/>
          <p:cNvSpPr/>
          <p:nvPr/>
        </p:nvSpPr>
        <p:spPr>
          <a:xfrm>
            <a:off x="1339920" y="354636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LR2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73"/>
          <p:cNvSpPr/>
          <p:nvPr/>
        </p:nvSpPr>
        <p:spPr>
          <a:xfrm>
            <a:off x="3905280" y="3305160"/>
            <a:ext cx="232740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'-accaaaactccctggaactcct-3'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4"/>
          <p:cNvSpPr/>
          <p:nvPr/>
        </p:nvSpPr>
        <p:spPr>
          <a:xfrm>
            <a:off x="2770200" y="2852640"/>
            <a:ext cx="71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R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8"/>
          <p:cNvSpPr/>
          <p:nvPr/>
        </p:nvSpPr>
        <p:spPr>
          <a:xfrm>
            <a:off x="2770200" y="3638520"/>
            <a:ext cx="71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R2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9"/>
          <p:cNvSpPr/>
          <p:nvPr/>
        </p:nvSpPr>
        <p:spPr>
          <a:xfrm>
            <a:off x="2770200" y="3305160"/>
            <a:ext cx="71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F2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11"/>
          <p:cNvSpPr/>
          <p:nvPr/>
        </p:nvSpPr>
        <p:spPr>
          <a:xfrm>
            <a:off x="2770200" y="4484520"/>
            <a:ext cx="71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R3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12"/>
          <p:cNvSpPr/>
          <p:nvPr/>
        </p:nvSpPr>
        <p:spPr>
          <a:xfrm>
            <a:off x="2770200" y="4151160"/>
            <a:ext cx="71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F3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15"/>
          <p:cNvSpPr/>
          <p:nvPr/>
        </p:nvSpPr>
        <p:spPr>
          <a:xfrm>
            <a:off x="3905280" y="3638520"/>
            <a:ext cx="232740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'-tgtctcagaggctcatgttct-3'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19"/>
          <p:cNvSpPr/>
          <p:nvPr/>
        </p:nvSpPr>
        <p:spPr>
          <a:xfrm>
            <a:off x="3905280" y="2879640"/>
            <a:ext cx="232740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'-agaggagacagcaattccaa-3'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26"/>
          <p:cNvSpPr/>
          <p:nvPr/>
        </p:nvSpPr>
        <p:spPr>
          <a:xfrm>
            <a:off x="3905280" y="4178160"/>
            <a:ext cx="232740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'-ccctacagccaaacgatctac-3'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29"/>
          <p:cNvSpPr/>
          <p:nvPr/>
        </p:nvSpPr>
        <p:spPr>
          <a:xfrm>
            <a:off x="3905280" y="4510800"/>
            <a:ext cx="232740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'-gtgccctacctgcgggaagagtc-3'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31"/>
          <p:cNvSpPr/>
          <p:nvPr/>
        </p:nvSpPr>
        <p:spPr>
          <a:xfrm>
            <a:off x="5924520" y="435600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~12k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32"/>
          <p:cNvSpPr/>
          <p:nvPr/>
        </p:nvSpPr>
        <p:spPr>
          <a:xfrm>
            <a:off x="5924520" y="3538440"/>
            <a:ext cx="244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~9.6k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33"/>
          <p:cNvSpPr/>
          <p:nvPr/>
        </p:nvSpPr>
        <p:spPr>
          <a:xfrm>
            <a:off x="5924520" y="278928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~9k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34"/>
          <p:cNvSpPr/>
          <p:nvPr/>
        </p:nvSpPr>
        <p:spPr>
          <a:xfrm>
            <a:off x="1339920" y="2058840"/>
            <a:ext cx="825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Primer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本框 37"/>
          <p:cNvSpPr/>
          <p:nvPr/>
        </p:nvSpPr>
        <p:spPr>
          <a:xfrm>
            <a:off x="4637160" y="2076480"/>
            <a:ext cx="12016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equenc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本框 38"/>
          <p:cNvSpPr/>
          <p:nvPr/>
        </p:nvSpPr>
        <p:spPr>
          <a:xfrm>
            <a:off x="6881760" y="2117880"/>
            <a:ext cx="646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iz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本框 10"/>
          <p:cNvSpPr/>
          <p:nvPr/>
        </p:nvSpPr>
        <p:spPr>
          <a:xfrm>
            <a:off x="2525760" y="2077920"/>
            <a:ext cx="824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Direc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3:53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